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200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80D7-5182-45B0-BFB3-B9F8D8394B0F}" type="datetimeFigureOut">
              <a:rPr lang="zh-CN" altLang="en-US" smtClean="0"/>
              <a:t>2020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E7784-D61D-4C7D-9543-5FB5509BE87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80D7-5182-45B0-BFB3-B9F8D8394B0F}" type="datetimeFigureOut">
              <a:rPr lang="zh-CN" altLang="en-US" smtClean="0"/>
              <a:t>2020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E7784-D61D-4C7D-9543-5FB5509BE87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80D7-5182-45B0-BFB3-B9F8D8394B0F}" type="datetimeFigureOut">
              <a:rPr lang="zh-CN" altLang="en-US" smtClean="0"/>
              <a:t>2020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E7784-D61D-4C7D-9543-5FB5509BE87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80D7-5182-45B0-BFB3-B9F8D8394B0F}" type="datetimeFigureOut">
              <a:rPr lang="zh-CN" altLang="en-US" smtClean="0"/>
              <a:t>2020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E7784-D61D-4C7D-9543-5FB5509BE87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80D7-5182-45B0-BFB3-B9F8D8394B0F}" type="datetimeFigureOut">
              <a:rPr lang="zh-CN" altLang="en-US" smtClean="0"/>
              <a:t>2020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E7784-D61D-4C7D-9543-5FB5509BE87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 hasCustomPrompt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80D7-5182-45B0-BFB3-B9F8D8394B0F}" type="datetimeFigureOut">
              <a:rPr lang="zh-CN" altLang="en-US" smtClean="0"/>
              <a:t>2020/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E7784-D61D-4C7D-9543-5FB5509BE87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 hasCustomPrompt="1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80D7-5182-45B0-BFB3-B9F8D8394B0F}" type="datetimeFigureOut">
              <a:rPr lang="zh-CN" altLang="en-US" smtClean="0"/>
              <a:t>2020/2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E7784-D61D-4C7D-9543-5FB5509BE87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80D7-5182-45B0-BFB3-B9F8D8394B0F}" type="datetimeFigureOut">
              <a:rPr lang="zh-CN" altLang="en-US" smtClean="0"/>
              <a:t>2020/2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E7784-D61D-4C7D-9543-5FB5509BE87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80D7-5182-45B0-BFB3-B9F8D8394B0F}" type="datetimeFigureOut">
              <a:rPr lang="zh-CN" altLang="en-US" smtClean="0"/>
              <a:t>2020/2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E7784-D61D-4C7D-9543-5FB5509BE87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80D7-5182-45B0-BFB3-B9F8D8394B0F}" type="datetimeFigureOut">
              <a:rPr lang="zh-CN" altLang="en-US" smtClean="0"/>
              <a:t>2020/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E7784-D61D-4C7D-9543-5FB5509BE87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80D7-5182-45B0-BFB3-B9F8D8394B0F}" type="datetimeFigureOut">
              <a:rPr lang="zh-CN" altLang="en-US" smtClean="0"/>
              <a:t>2020/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E7784-D61D-4C7D-9543-5FB5509BE87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0680D7-5182-45B0-BFB3-B9F8D8394B0F}" type="datetimeFigureOut">
              <a:rPr lang="zh-CN" altLang="en-US" smtClean="0"/>
              <a:t>2020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FE7784-D61D-4C7D-9543-5FB5509BE87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F69BA1D-E50A-CB4E-9AAC-9364B9CA77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altLang="zh-CN" sz="3600" b="1" dirty="0"/>
              <a:t>Supplementary</a:t>
            </a:r>
            <a:r>
              <a:rPr lang="en-US" altLang="zh-CN" dirty="0"/>
              <a:t> </a:t>
            </a:r>
            <a:endParaRPr lang="zh-CN" altLang="zh-CN" dirty="0"/>
          </a:p>
          <a:p>
            <a:r>
              <a:rPr lang="en-US" altLang="zh-CN" dirty="0"/>
              <a:t>Figure S1. ﻿Flowchart of patients operated for soft tissue sarcoma of the extremity and abdominothoracic wall 1995-2016.</a:t>
            </a:r>
            <a:endParaRPr lang="zh-CN" altLang="zh-CN" dirty="0"/>
          </a:p>
          <a:p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1417385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组合 17"/>
          <p:cNvGrpSpPr/>
          <p:nvPr/>
        </p:nvGrpSpPr>
        <p:grpSpPr>
          <a:xfrm>
            <a:off x="3759200" y="189865"/>
            <a:ext cx="3437255" cy="6212840"/>
            <a:chOff x="3759195" y="189779"/>
            <a:chExt cx="3267245" cy="6213027"/>
          </a:xfrm>
        </p:grpSpPr>
        <p:sp>
          <p:nvSpPr>
            <p:cNvPr id="4" name="圆角矩形 3"/>
            <p:cNvSpPr/>
            <p:nvPr/>
          </p:nvSpPr>
          <p:spPr>
            <a:xfrm>
              <a:off x="3759201" y="189779"/>
              <a:ext cx="3267235" cy="804832"/>
            </a:xfrm>
            <a:prstGeom prst="round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itial Patient Cohort</a:t>
              </a:r>
            </a:p>
            <a:p>
              <a:pPr algn="ctr"/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 = 769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圆角矩形 4"/>
            <p:cNvSpPr/>
            <p:nvPr/>
          </p:nvSpPr>
          <p:spPr>
            <a:xfrm>
              <a:off x="3759197" y="1267392"/>
              <a:ext cx="3267241" cy="804832"/>
            </a:xfrm>
            <a:prstGeom prst="round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st to </a:t>
              </a:r>
              <a:r>
                <a:rPr lang="en-US" altLang="zh-CN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ollow-up</a:t>
              </a:r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77)</a:t>
              </a:r>
            </a:p>
            <a:p>
              <a:pPr algn="ctr"/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 = 692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圆角矩形 6"/>
            <p:cNvSpPr/>
            <p:nvPr/>
          </p:nvSpPr>
          <p:spPr>
            <a:xfrm>
              <a:off x="3759196" y="4525399"/>
              <a:ext cx="3267241" cy="804832"/>
            </a:xfrm>
            <a:prstGeom prst="round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astatic disease</a:t>
              </a:r>
            </a:p>
            <a:p>
              <a:pPr algn="ctr"/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 diagnosis or as a first event (82)</a:t>
              </a:r>
            </a:p>
            <a:p>
              <a:pPr algn="ctr"/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 = 477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圆角矩形 7"/>
            <p:cNvSpPr/>
            <p:nvPr/>
          </p:nvSpPr>
          <p:spPr>
            <a:xfrm>
              <a:off x="3759195" y="3406459"/>
              <a:ext cx="3267241" cy="804832"/>
            </a:xfrm>
            <a:prstGeom prst="round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  </a:t>
              </a:r>
              <a:r>
                <a:rPr lang="en-US" altLang="zh-CN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troperitoneally</a:t>
              </a:r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intra-abdominally etc. (128) </a:t>
              </a:r>
            </a:p>
            <a:p>
              <a:pPr algn="ctr"/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 = 559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圆角矩形 8"/>
            <p:cNvSpPr/>
            <p:nvPr/>
          </p:nvSpPr>
          <p:spPr>
            <a:xfrm>
              <a:off x="3759199" y="5597974"/>
              <a:ext cx="3267241" cy="804832"/>
            </a:xfrm>
            <a:prstGeom prst="round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nal Patient Cohort</a:t>
              </a:r>
            </a:p>
          </p:txBody>
        </p:sp>
        <p:sp>
          <p:nvSpPr>
            <p:cNvPr id="10" name="圆角矩形 9"/>
            <p:cNvSpPr/>
            <p:nvPr/>
          </p:nvSpPr>
          <p:spPr>
            <a:xfrm>
              <a:off x="3759195" y="2335405"/>
              <a:ext cx="3267241" cy="804832"/>
            </a:xfrm>
            <a:prstGeom prst="round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pt-BR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compl</a:t>
              </a:r>
              <a:r>
                <a:rPr lang="en-US" altLang="pt-B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r>
                <a:rPr lang="pt-BR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 Medical Records (</a:t>
              </a:r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r>
                <a:rPr lang="pt-BR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  <a:p>
              <a:pPr algn="ctr"/>
              <a:r>
                <a:rPr lang="pt-BR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 = 6</a:t>
              </a:r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7</a:t>
              </a:r>
            </a:p>
            <a:p>
              <a:pPr algn="ctr"/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下箭头 10"/>
            <p:cNvSpPr/>
            <p:nvPr/>
          </p:nvSpPr>
          <p:spPr>
            <a:xfrm>
              <a:off x="5236407" y="995580"/>
              <a:ext cx="312815" cy="263181"/>
            </a:xfrm>
            <a:prstGeom prst="downArrow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" name="下箭头 11"/>
            <p:cNvSpPr/>
            <p:nvPr/>
          </p:nvSpPr>
          <p:spPr>
            <a:xfrm>
              <a:off x="5236407" y="2072224"/>
              <a:ext cx="312815" cy="263181"/>
            </a:xfrm>
            <a:prstGeom prst="downArrow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" name="下箭头 12"/>
            <p:cNvSpPr/>
            <p:nvPr/>
          </p:nvSpPr>
          <p:spPr>
            <a:xfrm>
              <a:off x="5236406" y="3132215"/>
              <a:ext cx="312815" cy="263181"/>
            </a:xfrm>
            <a:prstGeom prst="downArrow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14" name="下箭头 13"/>
            <p:cNvSpPr/>
            <p:nvPr/>
          </p:nvSpPr>
          <p:spPr>
            <a:xfrm>
              <a:off x="5236406" y="4211050"/>
              <a:ext cx="312815" cy="263181"/>
            </a:xfrm>
            <a:prstGeom prst="downArrow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16" name="下箭头 15"/>
            <p:cNvSpPr/>
            <p:nvPr/>
          </p:nvSpPr>
          <p:spPr>
            <a:xfrm>
              <a:off x="5236406" y="5330231"/>
              <a:ext cx="312815" cy="263181"/>
            </a:xfrm>
            <a:prstGeom prst="downArrow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no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7</Words>
  <Application>Microsoft Macintosh PowerPoint</Application>
  <PresentationFormat>宽屏</PresentationFormat>
  <Paragraphs>15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Hong Evelyn</cp:lastModifiedBy>
  <cp:revision>13</cp:revision>
  <dcterms:created xsi:type="dcterms:W3CDTF">2019-02-20T07:43:00Z</dcterms:created>
  <dcterms:modified xsi:type="dcterms:W3CDTF">2020-02-22T10:15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145</vt:lpwstr>
  </property>
</Properties>
</file>